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11887200" cy="13716000"/>
  <p:notesSz cx="6858000" cy="9144000"/>
  <p:defaultTextStyle>
    <a:defPPr>
      <a:defRPr lang="en-US"/>
    </a:defPPr>
    <a:lvl1pPr marL="0" algn="l" defTabSz="1814170" rtl="0" eaLnBrk="1" latinLnBrk="0" hangingPunct="1">
      <a:defRPr sz="3571" kern="1200">
        <a:solidFill>
          <a:schemeClr val="tx1"/>
        </a:solidFill>
        <a:latin typeface="+mn-lt"/>
        <a:ea typeface="+mn-ea"/>
        <a:cs typeface="+mn-cs"/>
      </a:defRPr>
    </a:lvl1pPr>
    <a:lvl2pPr marL="907085" algn="l" defTabSz="1814170" rtl="0" eaLnBrk="1" latinLnBrk="0" hangingPunct="1">
      <a:defRPr sz="3571" kern="1200">
        <a:solidFill>
          <a:schemeClr val="tx1"/>
        </a:solidFill>
        <a:latin typeface="+mn-lt"/>
        <a:ea typeface="+mn-ea"/>
        <a:cs typeface="+mn-cs"/>
      </a:defRPr>
    </a:lvl2pPr>
    <a:lvl3pPr marL="1814170" algn="l" defTabSz="1814170" rtl="0" eaLnBrk="1" latinLnBrk="0" hangingPunct="1">
      <a:defRPr sz="3571" kern="1200">
        <a:solidFill>
          <a:schemeClr val="tx1"/>
        </a:solidFill>
        <a:latin typeface="+mn-lt"/>
        <a:ea typeface="+mn-ea"/>
        <a:cs typeface="+mn-cs"/>
      </a:defRPr>
    </a:lvl3pPr>
    <a:lvl4pPr marL="2721254" algn="l" defTabSz="1814170" rtl="0" eaLnBrk="1" latinLnBrk="0" hangingPunct="1">
      <a:defRPr sz="3571" kern="1200">
        <a:solidFill>
          <a:schemeClr val="tx1"/>
        </a:solidFill>
        <a:latin typeface="+mn-lt"/>
        <a:ea typeface="+mn-ea"/>
        <a:cs typeface="+mn-cs"/>
      </a:defRPr>
    </a:lvl4pPr>
    <a:lvl5pPr marL="3628339" algn="l" defTabSz="1814170" rtl="0" eaLnBrk="1" latinLnBrk="0" hangingPunct="1">
      <a:defRPr sz="3571" kern="1200">
        <a:solidFill>
          <a:schemeClr val="tx1"/>
        </a:solidFill>
        <a:latin typeface="+mn-lt"/>
        <a:ea typeface="+mn-ea"/>
        <a:cs typeface="+mn-cs"/>
      </a:defRPr>
    </a:lvl5pPr>
    <a:lvl6pPr marL="4535424" algn="l" defTabSz="1814170" rtl="0" eaLnBrk="1" latinLnBrk="0" hangingPunct="1">
      <a:defRPr sz="3571" kern="1200">
        <a:solidFill>
          <a:schemeClr val="tx1"/>
        </a:solidFill>
        <a:latin typeface="+mn-lt"/>
        <a:ea typeface="+mn-ea"/>
        <a:cs typeface="+mn-cs"/>
      </a:defRPr>
    </a:lvl6pPr>
    <a:lvl7pPr marL="5442509" algn="l" defTabSz="1814170" rtl="0" eaLnBrk="1" latinLnBrk="0" hangingPunct="1">
      <a:defRPr sz="3571" kern="1200">
        <a:solidFill>
          <a:schemeClr val="tx1"/>
        </a:solidFill>
        <a:latin typeface="+mn-lt"/>
        <a:ea typeface="+mn-ea"/>
        <a:cs typeface="+mn-cs"/>
      </a:defRPr>
    </a:lvl7pPr>
    <a:lvl8pPr marL="6349594" algn="l" defTabSz="1814170" rtl="0" eaLnBrk="1" latinLnBrk="0" hangingPunct="1">
      <a:defRPr sz="3571" kern="1200">
        <a:solidFill>
          <a:schemeClr val="tx1"/>
        </a:solidFill>
        <a:latin typeface="+mn-lt"/>
        <a:ea typeface="+mn-ea"/>
        <a:cs typeface="+mn-cs"/>
      </a:defRPr>
    </a:lvl8pPr>
    <a:lvl9pPr marL="7256678" algn="l" defTabSz="1814170" rtl="0" eaLnBrk="1" latinLnBrk="0" hangingPunct="1">
      <a:defRPr sz="357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6" d="100"/>
          <a:sy n="56" d="100"/>
        </p:scale>
        <p:origin x="262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1540" y="2244726"/>
            <a:ext cx="10104120" cy="4775200"/>
          </a:xfrm>
        </p:spPr>
        <p:txBody>
          <a:bodyPr anchor="b"/>
          <a:lstStyle>
            <a:lvl1pPr algn="ctr">
              <a:defRPr sz="78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7204076"/>
            <a:ext cx="8915400" cy="3311524"/>
          </a:xfrm>
        </p:spPr>
        <p:txBody>
          <a:bodyPr/>
          <a:lstStyle>
            <a:lvl1pPr marL="0" indent="0" algn="ctr">
              <a:buNone/>
              <a:defRPr sz="3120"/>
            </a:lvl1pPr>
            <a:lvl2pPr marL="594360" indent="0" algn="ctr">
              <a:buNone/>
              <a:defRPr sz="2600"/>
            </a:lvl2pPr>
            <a:lvl3pPr marL="1188720" indent="0" algn="ctr">
              <a:buNone/>
              <a:defRPr sz="2340"/>
            </a:lvl3pPr>
            <a:lvl4pPr marL="1783080" indent="0" algn="ctr">
              <a:buNone/>
              <a:defRPr sz="2080"/>
            </a:lvl4pPr>
            <a:lvl5pPr marL="2377440" indent="0" algn="ctr">
              <a:buNone/>
              <a:defRPr sz="2080"/>
            </a:lvl5pPr>
            <a:lvl6pPr marL="2971800" indent="0" algn="ctr">
              <a:buNone/>
              <a:defRPr sz="2080"/>
            </a:lvl6pPr>
            <a:lvl7pPr marL="3566160" indent="0" algn="ctr">
              <a:buNone/>
              <a:defRPr sz="2080"/>
            </a:lvl7pPr>
            <a:lvl8pPr marL="4160520" indent="0" algn="ctr">
              <a:buNone/>
              <a:defRPr sz="2080"/>
            </a:lvl8pPr>
            <a:lvl9pPr marL="4754880" indent="0" algn="ctr">
              <a:buNone/>
              <a:defRPr sz="208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8987A-AAE0-4ABC-98E3-34FF52A043FE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65E0-6568-444D-8F7C-0AF8B96A13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806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8987A-AAE0-4ABC-98E3-34FF52A043FE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65E0-6568-444D-8F7C-0AF8B96A13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014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06778" y="730250"/>
            <a:ext cx="2563178" cy="1162367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17245" y="730250"/>
            <a:ext cx="7540943" cy="1162367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8987A-AAE0-4ABC-98E3-34FF52A043FE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65E0-6568-444D-8F7C-0AF8B96A13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162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8987A-AAE0-4ABC-98E3-34FF52A043FE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65E0-6568-444D-8F7C-0AF8B96A13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519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1054" y="3419479"/>
            <a:ext cx="10252710" cy="5705474"/>
          </a:xfrm>
        </p:spPr>
        <p:txBody>
          <a:bodyPr anchor="b"/>
          <a:lstStyle>
            <a:lvl1pPr>
              <a:defRPr sz="78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1054" y="9178929"/>
            <a:ext cx="10252710" cy="3000374"/>
          </a:xfrm>
        </p:spPr>
        <p:txBody>
          <a:bodyPr/>
          <a:lstStyle>
            <a:lvl1pPr marL="0" indent="0">
              <a:buNone/>
              <a:defRPr sz="3120">
                <a:solidFill>
                  <a:schemeClr val="tx1"/>
                </a:solidFill>
              </a:defRPr>
            </a:lvl1pPr>
            <a:lvl2pPr marL="59436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188720" indent="0">
              <a:buNone/>
              <a:defRPr sz="2340">
                <a:solidFill>
                  <a:schemeClr val="tx1">
                    <a:tint val="75000"/>
                  </a:schemeClr>
                </a:solidFill>
              </a:defRPr>
            </a:lvl3pPr>
            <a:lvl4pPr marL="178308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4pPr>
            <a:lvl5pPr marL="237744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5pPr>
            <a:lvl6pPr marL="297180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6pPr>
            <a:lvl7pPr marL="356616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7pPr>
            <a:lvl8pPr marL="416052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8pPr>
            <a:lvl9pPr marL="475488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8987A-AAE0-4ABC-98E3-34FF52A043FE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65E0-6568-444D-8F7C-0AF8B96A13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7176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17245" y="3651250"/>
            <a:ext cx="5052060" cy="870267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17895" y="3651250"/>
            <a:ext cx="5052060" cy="870267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8987A-AAE0-4ABC-98E3-34FF52A043FE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65E0-6568-444D-8F7C-0AF8B96A13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853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3" y="730253"/>
            <a:ext cx="10252710" cy="265112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8795" y="3362326"/>
            <a:ext cx="5028842" cy="1647824"/>
          </a:xfrm>
        </p:spPr>
        <p:txBody>
          <a:bodyPr anchor="b"/>
          <a:lstStyle>
            <a:lvl1pPr marL="0" indent="0">
              <a:buNone/>
              <a:defRPr sz="3120" b="1"/>
            </a:lvl1pPr>
            <a:lvl2pPr marL="594360" indent="0">
              <a:buNone/>
              <a:defRPr sz="2600" b="1"/>
            </a:lvl2pPr>
            <a:lvl3pPr marL="1188720" indent="0">
              <a:buNone/>
              <a:defRPr sz="2340" b="1"/>
            </a:lvl3pPr>
            <a:lvl4pPr marL="1783080" indent="0">
              <a:buNone/>
              <a:defRPr sz="2080" b="1"/>
            </a:lvl4pPr>
            <a:lvl5pPr marL="2377440" indent="0">
              <a:buNone/>
              <a:defRPr sz="2080" b="1"/>
            </a:lvl5pPr>
            <a:lvl6pPr marL="2971800" indent="0">
              <a:buNone/>
              <a:defRPr sz="2080" b="1"/>
            </a:lvl6pPr>
            <a:lvl7pPr marL="3566160" indent="0">
              <a:buNone/>
              <a:defRPr sz="2080" b="1"/>
            </a:lvl7pPr>
            <a:lvl8pPr marL="4160520" indent="0">
              <a:buNone/>
              <a:defRPr sz="2080" b="1"/>
            </a:lvl8pPr>
            <a:lvl9pPr marL="4754880" indent="0">
              <a:buNone/>
              <a:defRPr sz="208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18795" y="5010150"/>
            <a:ext cx="5028842" cy="736917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17896" y="3362326"/>
            <a:ext cx="5053608" cy="1647824"/>
          </a:xfrm>
        </p:spPr>
        <p:txBody>
          <a:bodyPr anchor="b"/>
          <a:lstStyle>
            <a:lvl1pPr marL="0" indent="0">
              <a:buNone/>
              <a:defRPr sz="3120" b="1"/>
            </a:lvl1pPr>
            <a:lvl2pPr marL="594360" indent="0">
              <a:buNone/>
              <a:defRPr sz="2600" b="1"/>
            </a:lvl2pPr>
            <a:lvl3pPr marL="1188720" indent="0">
              <a:buNone/>
              <a:defRPr sz="2340" b="1"/>
            </a:lvl3pPr>
            <a:lvl4pPr marL="1783080" indent="0">
              <a:buNone/>
              <a:defRPr sz="2080" b="1"/>
            </a:lvl4pPr>
            <a:lvl5pPr marL="2377440" indent="0">
              <a:buNone/>
              <a:defRPr sz="2080" b="1"/>
            </a:lvl5pPr>
            <a:lvl6pPr marL="2971800" indent="0">
              <a:buNone/>
              <a:defRPr sz="2080" b="1"/>
            </a:lvl6pPr>
            <a:lvl7pPr marL="3566160" indent="0">
              <a:buNone/>
              <a:defRPr sz="2080" b="1"/>
            </a:lvl7pPr>
            <a:lvl8pPr marL="4160520" indent="0">
              <a:buNone/>
              <a:defRPr sz="2080" b="1"/>
            </a:lvl8pPr>
            <a:lvl9pPr marL="4754880" indent="0">
              <a:buNone/>
              <a:defRPr sz="208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17896" y="5010150"/>
            <a:ext cx="5053608" cy="736917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8987A-AAE0-4ABC-98E3-34FF52A043FE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65E0-6568-444D-8F7C-0AF8B96A13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110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8987A-AAE0-4ABC-98E3-34FF52A043FE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65E0-6568-444D-8F7C-0AF8B96A13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601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8987A-AAE0-4ABC-98E3-34FF52A043FE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65E0-6568-444D-8F7C-0AF8B96A13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447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4" y="914400"/>
            <a:ext cx="3833931" cy="3200400"/>
          </a:xfrm>
        </p:spPr>
        <p:txBody>
          <a:bodyPr anchor="b"/>
          <a:lstStyle>
            <a:lvl1pPr>
              <a:defRPr sz="416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53608" y="1974853"/>
            <a:ext cx="6017895" cy="9747250"/>
          </a:xfrm>
        </p:spPr>
        <p:txBody>
          <a:bodyPr/>
          <a:lstStyle>
            <a:lvl1pPr>
              <a:defRPr sz="4160"/>
            </a:lvl1pPr>
            <a:lvl2pPr>
              <a:defRPr sz="3640"/>
            </a:lvl2pPr>
            <a:lvl3pPr>
              <a:defRPr sz="312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794" y="4114800"/>
            <a:ext cx="3833931" cy="7623176"/>
          </a:xfrm>
        </p:spPr>
        <p:txBody>
          <a:bodyPr/>
          <a:lstStyle>
            <a:lvl1pPr marL="0" indent="0">
              <a:buNone/>
              <a:defRPr sz="2080"/>
            </a:lvl1pPr>
            <a:lvl2pPr marL="594360" indent="0">
              <a:buNone/>
              <a:defRPr sz="1820"/>
            </a:lvl2pPr>
            <a:lvl3pPr marL="1188720" indent="0">
              <a:buNone/>
              <a:defRPr sz="1560"/>
            </a:lvl3pPr>
            <a:lvl4pPr marL="1783080" indent="0">
              <a:buNone/>
              <a:defRPr sz="1300"/>
            </a:lvl4pPr>
            <a:lvl5pPr marL="2377440" indent="0">
              <a:buNone/>
              <a:defRPr sz="1300"/>
            </a:lvl5pPr>
            <a:lvl6pPr marL="2971800" indent="0">
              <a:buNone/>
              <a:defRPr sz="1300"/>
            </a:lvl6pPr>
            <a:lvl7pPr marL="3566160" indent="0">
              <a:buNone/>
              <a:defRPr sz="1300"/>
            </a:lvl7pPr>
            <a:lvl8pPr marL="4160520" indent="0">
              <a:buNone/>
              <a:defRPr sz="1300"/>
            </a:lvl8pPr>
            <a:lvl9pPr marL="4754880" indent="0">
              <a:buNone/>
              <a:defRPr sz="13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8987A-AAE0-4ABC-98E3-34FF52A043FE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65E0-6568-444D-8F7C-0AF8B96A13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0029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4" y="914400"/>
            <a:ext cx="3833931" cy="3200400"/>
          </a:xfrm>
        </p:spPr>
        <p:txBody>
          <a:bodyPr anchor="b"/>
          <a:lstStyle>
            <a:lvl1pPr>
              <a:defRPr sz="416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053608" y="1974853"/>
            <a:ext cx="6017895" cy="9747250"/>
          </a:xfrm>
        </p:spPr>
        <p:txBody>
          <a:bodyPr anchor="t"/>
          <a:lstStyle>
            <a:lvl1pPr marL="0" indent="0">
              <a:buNone/>
              <a:defRPr sz="4160"/>
            </a:lvl1pPr>
            <a:lvl2pPr marL="594360" indent="0">
              <a:buNone/>
              <a:defRPr sz="3640"/>
            </a:lvl2pPr>
            <a:lvl3pPr marL="1188720" indent="0">
              <a:buNone/>
              <a:defRPr sz="3120"/>
            </a:lvl3pPr>
            <a:lvl4pPr marL="1783080" indent="0">
              <a:buNone/>
              <a:defRPr sz="2600"/>
            </a:lvl4pPr>
            <a:lvl5pPr marL="2377440" indent="0">
              <a:buNone/>
              <a:defRPr sz="2600"/>
            </a:lvl5pPr>
            <a:lvl6pPr marL="2971800" indent="0">
              <a:buNone/>
              <a:defRPr sz="2600"/>
            </a:lvl6pPr>
            <a:lvl7pPr marL="3566160" indent="0">
              <a:buNone/>
              <a:defRPr sz="2600"/>
            </a:lvl7pPr>
            <a:lvl8pPr marL="4160520" indent="0">
              <a:buNone/>
              <a:defRPr sz="2600"/>
            </a:lvl8pPr>
            <a:lvl9pPr marL="4754880" indent="0">
              <a:buNone/>
              <a:defRPr sz="26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794" y="4114800"/>
            <a:ext cx="3833931" cy="7623176"/>
          </a:xfrm>
        </p:spPr>
        <p:txBody>
          <a:bodyPr/>
          <a:lstStyle>
            <a:lvl1pPr marL="0" indent="0">
              <a:buNone/>
              <a:defRPr sz="2080"/>
            </a:lvl1pPr>
            <a:lvl2pPr marL="594360" indent="0">
              <a:buNone/>
              <a:defRPr sz="1820"/>
            </a:lvl2pPr>
            <a:lvl3pPr marL="1188720" indent="0">
              <a:buNone/>
              <a:defRPr sz="1560"/>
            </a:lvl3pPr>
            <a:lvl4pPr marL="1783080" indent="0">
              <a:buNone/>
              <a:defRPr sz="1300"/>
            </a:lvl4pPr>
            <a:lvl5pPr marL="2377440" indent="0">
              <a:buNone/>
              <a:defRPr sz="1300"/>
            </a:lvl5pPr>
            <a:lvl6pPr marL="2971800" indent="0">
              <a:buNone/>
              <a:defRPr sz="1300"/>
            </a:lvl6pPr>
            <a:lvl7pPr marL="3566160" indent="0">
              <a:buNone/>
              <a:defRPr sz="1300"/>
            </a:lvl7pPr>
            <a:lvl8pPr marL="4160520" indent="0">
              <a:buNone/>
              <a:defRPr sz="1300"/>
            </a:lvl8pPr>
            <a:lvl9pPr marL="4754880" indent="0">
              <a:buNone/>
              <a:defRPr sz="13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8987A-AAE0-4ABC-98E3-34FF52A043FE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65E0-6568-444D-8F7C-0AF8B96A13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9036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17245" y="730253"/>
            <a:ext cx="1025271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7245" y="3651250"/>
            <a:ext cx="1025271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17245" y="12712703"/>
            <a:ext cx="267462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E8987A-AAE0-4ABC-98E3-34FF52A043FE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7635" y="12712703"/>
            <a:ext cx="401193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95335" y="12712703"/>
            <a:ext cx="267462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6665E0-6568-444D-8F7C-0AF8B96A13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280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188720" rtl="0" eaLnBrk="1" latinLnBrk="0" hangingPunct="1">
        <a:lnSpc>
          <a:spcPct val="90000"/>
        </a:lnSpc>
        <a:spcBef>
          <a:spcPct val="0"/>
        </a:spcBef>
        <a:buNone/>
        <a:defRPr sz="57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7180" indent="-297180" algn="l" defTabSz="118872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3640" kern="1200">
          <a:solidFill>
            <a:schemeClr val="tx1"/>
          </a:solidFill>
          <a:latin typeface="+mn-lt"/>
          <a:ea typeface="+mn-ea"/>
          <a:cs typeface="+mn-cs"/>
        </a:defRPr>
      </a:lvl1pPr>
      <a:lvl2pPr marL="89154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2pPr>
      <a:lvl3pPr marL="148590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208026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4pPr>
      <a:lvl5pPr marL="267462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5pPr>
      <a:lvl6pPr marL="326898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6pPr>
      <a:lvl7pPr marL="386334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7pPr>
      <a:lvl8pPr marL="445770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8pPr>
      <a:lvl9pPr marL="505206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1pPr>
      <a:lvl2pPr marL="59436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2pPr>
      <a:lvl3pPr marL="118872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3pPr>
      <a:lvl4pPr marL="178308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4pPr>
      <a:lvl5pPr marL="237744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5pPr>
      <a:lvl6pPr marL="297180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7pPr>
      <a:lvl8pPr marL="416052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8pPr>
      <a:lvl9pPr marL="475488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A8234AF2-FACB-4A4F-964D-9B629D555205}"/>
              </a:ext>
            </a:extLst>
          </p:cNvPr>
          <p:cNvGrpSpPr/>
          <p:nvPr/>
        </p:nvGrpSpPr>
        <p:grpSpPr>
          <a:xfrm>
            <a:off x="1207699" y="869008"/>
            <a:ext cx="7857486" cy="10121045"/>
            <a:chOff x="900729" y="610215"/>
            <a:chExt cx="9565186" cy="12320694"/>
          </a:xfrm>
        </p:grpSpPr>
        <p:pic>
          <p:nvPicPr>
            <p:cNvPr id="8" name="Picture 16874">
              <a:extLst>
                <a:ext uri="{FF2B5EF4-FFF2-40B4-BE49-F238E27FC236}">
                  <a16:creationId xmlns:a16="http://schemas.microsoft.com/office/drawing/2014/main" id="{12717B89-F5A7-8257-4899-5F6D2FAFD416}"/>
                </a:ext>
              </a:extLst>
            </p:cNvPr>
            <p:cNvPicPr/>
            <p:nvPr/>
          </p:nvPicPr>
          <p:blipFill>
            <a:blip r:embed="rId2"/>
            <a:stretch>
              <a:fillRect/>
            </a:stretch>
          </p:blipFill>
          <p:spPr>
            <a:xfrm>
              <a:off x="1496212" y="936318"/>
              <a:ext cx="8969703" cy="5244614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5307EB8-AF09-F0E4-97A2-687BE5BDE867}"/>
                </a:ext>
              </a:extLst>
            </p:cNvPr>
            <p:cNvSpPr txBox="1"/>
            <p:nvPr/>
          </p:nvSpPr>
          <p:spPr>
            <a:xfrm>
              <a:off x="9172409" y="944279"/>
              <a:ext cx="1086468" cy="4496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800" b="1" dirty="0"/>
                <a:t>DMSO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FB3A24B-803C-4119-196E-894C50CC7011}"/>
                </a:ext>
              </a:extLst>
            </p:cNvPr>
            <p:cNvSpPr txBox="1"/>
            <p:nvPr/>
          </p:nvSpPr>
          <p:spPr>
            <a:xfrm>
              <a:off x="900729" y="610215"/>
              <a:ext cx="528864" cy="71186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3200" b="1" dirty="0"/>
                <a:t>A</a:t>
              </a:r>
              <a:endParaRPr lang="ko-KR" altLang="en-US" sz="3200" dirty="0"/>
            </a:p>
          </p:txBody>
        </p:sp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EF091BBE-BA55-9E2B-85AB-C0B664C31737}"/>
                </a:ext>
              </a:extLst>
            </p:cNvPr>
            <p:cNvGrpSpPr/>
            <p:nvPr/>
          </p:nvGrpSpPr>
          <p:grpSpPr>
            <a:xfrm>
              <a:off x="1496212" y="6849047"/>
              <a:ext cx="8969703" cy="6081862"/>
              <a:chOff x="687159" y="691697"/>
              <a:chExt cx="10099221" cy="5905046"/>
            </a:xfrm>
          </p:grpSpPr>
          <p:pic>
            <p:nvPicPr>
              <p:cNvPr id="6" name="Picture 16844"/>
              <p:cNvPicPr/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87159" y="691697"/>
                <a:ext cx="10099221" cy="5905046"/>
              </a:xfrm>
              <a:prstGeom prst="rect">
                <a:avLst/>
              </a:prstGeom>
            </p:spPr>
          </p:pic>
          <p:sp>
            <p:nvSpPr>
              <p:cNvPr id="7" name="직사각형 6"/>
              <p:cNvSpPr/>
              <p:nvPr/>
            </p:nvSpPr>
            <p:spPr>
              <a:xfrm rot="18429404">
                <a:off x="5608617" y="4356233"/>
                <a:ext cx="1001213" cy="42184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Calibri" panose="020F0502020204030204" pitchFamily="34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anethole</a:t>
                </a:r>
                <a:endParaRPr lang="en-US" sz="1400" b="1" dirty="0"/>
              </a:p>
            </p:txBody>
          </p:sp>
          <p:sp>
            <p:nvSpPr>
              <p:cNvPr id="10" name="직사각형 9"/>
              <p:cNvSpPr/>
              <p:nvPr/>
            </p:nvSpPr>
            <p:spPr>
              <a:xfrm rot="18302679">
                <a:off x="5516437" y="3629277"/>
                <a:ext cx="3313378" cy="42184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Calibri" panose="020F0502020204030204" pitchFamily="34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1-(4-methoxyphenyl)-2-propanone </a:t>
                </a:r>
                <a:endParaRPr lang="en-US" sz="1400" b="1" dirty="0"/>
              </a:p>
            </p:txBody>
          </p:sp>
          <p:sp>
            <p:nvSpPr>
              <p:cNvPr id="11" name="직사각형 10"/>
              <p:cNvSpPr/>
              <p:nvPr/>
            </p:nvSpPr>
            <p:spPr>
              <a:xfrm rot="18234212">
                <a:off x="6055905" y="3816202"/>
                <a:ext cx="2948969" cy="42184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 err="1">
                    <a:latin typeface="Calibri" panose="020F0502020204030204" pitchFamily="34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ethoxydimethylphenylsilane</a:t>
                </a:r>
                <a:endParaRPr lang="en-US" sz="1400" b="1" dirty="0"/>
              </a:p>
            </p:txBody>
          </p:sp>
          <p:sp>
            <p:nvSpPr>
              <p:cNvPr id="13" name="직사각형 12"/>
              <p:cNvSpPr/>
              <p:nvPr/>
            </p:nvSpPr>
            <p:spPr>
              <a:xfrm rot="18235895">
                <a:off x="6432518" y="3847396"/>
                <a:ext cx="3067072" cy="42184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Calibri" panose="020F0502020204030204" pitchFamily="34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para-anisaldehyde diethyl acetal</a:t>
                </a:r>
                <a:endParaRPr lang="en-US" sz="1400" b="1" dirty="0"/>
              </a:p>
            </p:txBody>
          </p: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40BDEC8-6D26-F3CA-9C4C-93096006F5DB}"/>
                </a:ext>
              </a:extLst>
            </p:cNvPr>
            <p:cNvSpPr txBox="1"/>
            <p:nvPr/>
          </p:nvSpPr>
          <p:spPr>
            <a:xfrm>
              <a:off x="9314347" y="6964637"/>
              <a:ext cx="786567" cy="4496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b="1" dirty="0"/>
                <a:t>FVSE</a:t>
              </a:r>
              <a:endParaRPr lang="en-US" sz="3200" b="1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CBEF2C0-588B-A78B-6E95-6515FD29A22D}"/>
                </a:ext>
              </a:extLst>
            </p:cNvPr>
            <p:cNvSpPr txBox="1"/>
            <p:nvPr/>
          </p:nvSpPr>
          <p:spPr>
            <a:xfrm>
              <a:off x="913737" y="6511882"/>
              <a:ext cx="528864" cy="71186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3200" b="1" dirty="0"/>
                <a:t>B</a:t>
              </a:r>
              <a:endParaRPr lang="ko-KR" altLang="en-US" sz="3200" dirty="0"/>
            </a:p>
          </p:txBody>
        </p:sp>
      </p:grpSp>
      <p:sp>
        <p:nvSpPr>
          <p:cNvPr id="3" name="직사각형 2">
            <a:extLst>
              <a:ext uri="{FF2B5EF4-FFF2-40B4-BE49-F238E27FC236}">
                <a16:creationId xmlns:a16="http://schemas.microsoft.com/office/drawing/2014/main" id="{7026F11B-8ACB-41D2-B5F4-56AF84419541}"/>
              </a:ext>
            </a:extLst>
          </p:cNvPr>
          <p:cNvSpPr/>
          <p:nvPr/>
        </p:nvSpPr>
        <p:spPr>
          <a:xfrm>
            <a:off x="1504056" y="11357695"/>
            <a:ext cx="9434868" cy="20515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20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 Figure 1. Gas Chromatography-Mass Spectrometry (GC-MS) Profile of F. vulgare Mill. Seed Ethanol Extracts (FVSE). The GC-MS analysis was performed as described in section 2.10, "Gas Chromatography-Mass Spectrometry (GC-MS) Analysis" in the Materials and Methods. (A) GC profile of the solvent DMSO. (B) GC profile of FVSE. The prominent peaks were identified by MS as marked phytochemicals.</a:t>
            </a:r>
          </a:p>
        </p:txBody>
      </p:sp>
    </p:spTree>
    <p:extLst>
      <p:ext uri="{BB962C8B-B14F-4D97-AF65-F5344CB8AC3E}">
        <p14:creationId xmlns:p14="http://schemas.microsoft.com/office/powerpoint/2010/main" val="3401542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</TotalTime>
  <Words>92</Words>
  <Application>Microsoft Office PowerPoint</Application>
  <PresentationFormat>사용자 지정</PresentationFormat>
  <Paragraphs>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Palatino Linotype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MoonIS</cp:lastModifiedBy>
  <cp:revision>8</cp:revision>
  <dcterms:created xsi:type="dcterms:W3CDTF">2024-09-13T03:08:33Z</dcterms:created>
  <dcterms:modified xsi:type="dcterms:W3CDTF">2024-09-25T01:19:24Z</dcterms:modified>
</cp:coreProperties>
</file>